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1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687"/>
    <p:restoredTop sz="96327"/>
  </p:normalViewPr>
  <p:slideViewPr>
    <p:cSldViewPr snapToGrid="0" snapToObjects="1" showGuides="1">
      <p:cViewPr varScale="1">
        <p:scale>
          <a:sx n="124" d="100"/>
          <a:sy n="124" d="100"/>
        </p:scale>
        <p:origin x="280" y="16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APTIEUX Rae" userId="3a961199-96dc-4b2e-8ea9-3b6407fb953a" providerId="ADAL" clId="{7EA896CD-1D8F-274A-9416-C029065F84FC}"/>
    <pc:docChg chg="custSel addSld delSld modSld">
      <pc:chgData name="CAPTIEUX Rae" userId="3a961199-96dc-4b2e-8ea9-3b6407fb953a" providerId="ADAL" clId="{7EA896CD-1D8F-274A-9416-C029065F84FC}" dt="2020-09-01T19:38:14.149" v="2" actId="478"/>
      <pc:docMkLst>
        <pc:docMk/>
      </pc:docMkLst>
      <pc:sldChg chg="delSp add mod">
        <pc:chgData name="CAPTIEUX Rae" userId="3a961199-96dc-4b2e-8ea9-3b6407fb953a" providerId="ADAL" clId="{7EA896CD-1D8F-274A-9416-C029065F84FC}" dt="2020-09-01T19:38:14.149" v="2" actId="478"/>
        <pc:sldMkLst>
          <pc:docMk/>
          <pc:sldMk cId="2243796028" sldId="261"/>
        </pc:sldMkLst>
        <pc:spChg chg="del">
          <ac:chgData name="CAPTIEUX Rae" userId="3a961199-96dc-4b2e-8ea9-3b6407fb953a" providerId="ADAL" clId="{7EA896CD-1D8F-274A-9416-C029065F84FC}" dt="2020-09-01T19:38:14.149" v="2" actId="478"/>
          <ac:spMkLst>
            <pc:docMk/>
            <pc:sldMk cId="2243796028" sldId="261"/>
            <ac:spMk id="36" creationId="{77F841C4-F157-524B-905C-2353F0B3D360}"/>
          </ac:spMkLst>
        </pc:spChg>
      </pc:sldChg>
      <pc:sldChg chg="del">
        <pc:chgData name="CAPTIEUX Rae" userId="3a961199-96dc-4b2e-8ea9-3b6407fb953a" providerId="ADAL" clId="{7EA896CD-1D8F-274A-9416-C029065F84FC}" dt="2020-09-01T19:38:11.569" v="1" actId="2696"/>
        <pc:sldMkLst>
          <pc:docMk/>
          <pc:sldMk cId="4274590211" sldId="272"/>
        </pc:sldMkLst>
      </pc:sldChg>
    </pc:docChg>
  </pc:docChgLst>
  <pc:docChgLst>
    <pc:chgData name="CAPTIEUX Rae" userId="3a961199-96dc-4b2e-8ea9-3b6407fb953a" providerId="ADAL" clId="{8C173571-1730-9948-957E-AB42BC1BD641}"/>
    <pc:docChg chg="modSld">
      <pc:chgData name="CAPTIEUX Rae" userId="3a961199-96dc-4b2e-8ea9-3b6407fb953a" providerId="ADAL" clId="{8C173571-1730-9948-957E-AB42BC1BD641}" dt="2020-09-24T21:31:48.011" v="15" actId="20577"/>
      <pc:docMkLst>
        <pc:docMk/>
      </pc:docMkLst>
      <pc:sldChg chg="modSp mod">
        <pc:chgData name="CAPTIEUX Rae" userId="3a961199-96dc-4b2e-8ea9-3b6407fb953a" providerId="ADAL" clId="{8C173571-1730-9948-957E-AB42BC1BD641}" dt="2020-09-24T21:31:48.011" v="15" actId="20577"/>
        <pc:sldMkLst>
          <pc:docMk/>
          <pc:sldMk cId="2243796028" sldId="261"/>
        </pc:sldMkLst>
        <pc:spChg chg="mod">
          <ac:chgData name="CAPTIEUX Rae" userId="3a961199-96dc-4b2e-8ea9-3b6407fb953a" providerId="ADAL" clId="{8C173571-1730-9948-957E-AB42BC1BD641}" dt="2020-09-24T21:31:48.011" v="15" actId="20577"/>
          <ac:spMkLst>
            <pc:docMk/>
            <pc:sldMk cId="2243796028" sldId="261"/>
            <ac:spMk id="2" creationId="{DEBE7E83-37A9-EB4A-B5D8-3A02867923A3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DF1FCC1-6EE6-684D-9952-4592ABBC2FE9}" type="datetimeFigureOut">
              <a:rPr lang="en-US" smtClean="0"/>
              <a:t>9/24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14F5421-11C0-BE45-B08D-FC3C1ED8B1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248717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/>
              <a:t>P [3] Drug element missing</a:t>
            </a:r>
          </a:p>
          <a:p>
            <a:r>
              <a:rPr lang="en-GB"/>
              <a:t>Drug element missing [2] time element missing</a:t>
            </a:r>
          </a:p>
          <a:p>
            <a:r>
              <a:rPr lang="en-GB"/>
              <a:t>time element missing [1] "2009 consensus criteria"</a:t>
            </a:r>
          </a:p>
          <a:p>
            <a:r>
              <a:rPr lang="en-GB"/>
              <a:t>time element missing [1]&lt;48</a:t>
            </a:r>
          </a:p>
          <a:p>
            <a:endParaRPr lang="en-GB"/>
          </a:p>
          <a:p>
            <a:r>
              <a:rPr lang="en-GB"/>
              <a:t>Drug element missing[1] at 1y</a:t>
            </a:r>
          </a:p>
          <a:p>
            <a:r>
              <a:rPr lang="en-GB"/>
              <a:t>at 1y[1]&lt;42</a:t>
            </a:r>
          </a:p>
          <a:p>
            <a:endParaRPr lang="en-GB"/>
          </a:p>
          <a:p>
            <a:r>
              <a:rPr lang="en-GB"/>
              <a:t>:Drug element missing #C70039</a:t>
            </a:r>
          </a:p>
          <a:p>
            <a:r>
              <a:rPr lang="en-GB"/>
              <a:t>:time element missing #C70039</a:t>
            </a:r>
          </a:p>
          <a:p>
            <a:r>
              <a:rPr lang="en-GB"/>
              <a:t>:"2009 consensus criteria" #C70039</a:t>
            </a:r>
          </a:p>
          <a:p>
            <a:r>
              <a:rPr lang="en-GB"/>
              <a:t>:&lt;48 #C70039</a:t>
            </a:r>
          </a:p>
          <a:p>
            <a:r>
              <a:rPr lang="en-GB"/>
              <a:t>:&lt;48 #C70039</a:t>
            </a:r>
          </a:p>
          <a:p>
            <a:r>
              <a:rPr lang="en-GB"/>
              <a:t>:&lt;42 #5D6D7E</a:t>
            </a:r>
          </a:p>
          <a:p>
            <a:r>
              <a:rPr lang="en-GB"/>
              <a:t>:at 1y #C70039</a:t>
            </a:r>
          </a:p>
          <a:p>
            <a:endParaRPr lang="en-GB"/>
          </a:p>
          <a:p>
            <a:endParaRPr lang="en-GB"/>
          </a:p>
          <a:p>
            <a:r>
              <a:rPr lang="en-GB"/>
              <a:t>P [5] "some GLT prescribed"</a:t>
            </a:r>
          </a:p>
          <a:p>
            <a:r>
              <a:rPr lang="en-GB"/>
              <a:t>"some GLT prescribed" [2] time element missing</a:t>
            </a:r>
          </a:p>
          <a:p>
            <a:r>
              <a:rPr lang="en-GB"/>
              <a:t>time element missing[1] Normoglycaemia</a:t>
            </a:r>
          </a:p>
          <a:p>
            <a:r>
              <a:rPr lang="en-GB"/>
              <a:t>time element missing[1] &lt;48ORFPG&lt;7.0 </a:t>
            </a:r>
          </a:p>
          <a:p>
            <a:endParaRPr lang="en-GB"/>
          </a:p>
          <a:p>
            <a:r>
              <a:rPr lang="en-GB"/>
              <a:t>:"some GLT prescribed" #5D6D7E</a:t>
            </a:r>
          </a:p>
          <a:p>
            <a:r>
              <a:rPr lang="en-GB"/>
              <a:t>:time element missing #C70039</a:t>
            </a:r>
          </a:p>
          <a:p>
            <a:r>
              <a:rPr lang="en-GB"/>
              <a:t>:Normoglycaemia #C70039</a:t>
            </a:r>
          </a:p>
          <a:p>
            <a:r>
              <a:rPr lang="en-GB"/>
              <a:t>:&lt;48ORFPG&lt;7.0 #5D6D7E</a:t>
            </a:r>
          </a:p>
          <a:p>
            <a:endParaRPr lang="en-GB"/>
          </a:p>
          <a:p>
            <a:r>
              <a:rPr lang="en-GB"/>
              <a:t>"some GLT prescribed" [1] for 6 m</a:t>
            </a:r>
          </a:p>
          <a:p>
            <a:r>
              <a:rPr lang="en-GB"/>
              <a:t>for 6 m[1] ADA criteria</a:t>
            </a:r>
          </a:p>
          <a:p>
            <a:endParaRPr lang="en-GB"/>
          </a:p>
          <a:p>
            <a:r>
              <a:rPr lang="en-GB"/>
              <a:t>:for 6 m #5D6D7E</a:t>
            </a:r>
          </a:p>
          <a:p>
            <a:r>
              <a:rPr lang="en-GB"/>
              <a:t>:ADA criteria #C70039</a:t>
            </a:r>
          </a:p>
          <a:p>
            <a:endParaRPr lang="en-GB"/>
          </a:p>
          <a:p>
            <a:r>
              <a:rPr lang="en-GB"/>
              <a:t>:Time element missing #C70039</a:t>
            </a:r>
          </a:p>
          <a:p>
            <a:r>
              <a:rPr lang="en-GB"/>
              <a:t>:"for 6 months" #5D6D7E</a:t>
            </a:r>
          </a:p>
          <a:p>
            <a:endParaRPr lang="en-GB"/>
          </a:p>
          <a:p>
            <a:r>
              <a:rPr lang="en-GB"/>
              <a:t>"some GLT prescribed" [2] at 1y</a:t>
            </a:r>
          </a:p>
          <a:p>
            <a:r>
              <a:rPr lang="en-GB"/>
              <a:t>at 1y[2]&lt;48</a:t>
            </a:r>
          </a:p>
          <a:p>
            <a:endParaRPr lang="en-GB"/>
          </a:p>
          <a:p>
            <a:r>
              <a:rPr lang="en-GB"/>
              <a:t>:at 1y #5D6D7E</a:t>
            </a:r>
          </a:p>
          <a:p>
            <a:r>
              <a:rPr lang="en-GB"/>
              <a:t>:&lt;48 #5D6D7E</a:t>
            </a:r>
          </a:p>
          <a:p>
            <a:endParaRPr lang="en-GB"/>
          </a:p>
          <a:p>
            <a:r>
              <a:rPr lang="en-GB"/>
              <a:t>P [49] Drug element present</a:t>
            </a:r>
          </a:p>
          <a:p>
            <a:r>
              <a:rPr lang="en-GB"/>
              <a:t>Drug element present [16] time element missing</a:t>
            </a:r>
          </a:p>
          <a:p>
            <a:r>
              <a:rPr lang="en-GB"/>
              <a:t>time element missing [8]&lt;48</a:t>
            </a:r>
          </a:p>
          <a:p>
            <a:r>
              <a:rPr lang="en-GB"/>
              <a:t>time element missing [2]&lt;48,FPG&lt;7.0</a:t>
            </a:r>
          </a:p>
          <a:p>
            <a:r>
              <a:rPr lang="en-GB"/>
              <a:t>time element missing [1]&lt;48ORFPG&lt;7.0</a:t>
            </a:r>
          </a:p>
          <a:p>
            <a:r>
              <a:rPr lang="en-GB"/>
              <a:t>time element missing [5]&lt;48&amp;FPG&lt;7.0</a:t>
            </a:r>
          </a:p>
          <a:p>
            <a:endParaRPr lang="en-GB"/>
          </a:p>
          <a:p>
            <a:r>
              <a:rPr lang="en-GB"/>
              <a:t>:Drug element present  #5D6D7E</a:t>
            </a:r>
          </a:p>
          <a:p>
            <a:endParaRPr lang="en-GB"/>
          </a:p>
          <a:p>
            <a:r>
              <a:rPr lang="en-GB"/>
              <a:t>:time element missing #C70039</a:t>
            </a:r>
          </a:p>
          <a:p>
            <a:r>
              <a:rPr lang="en-GB"/>
              <a:t>:&lt;48  #C70039</a:t>
            </a:r>
          </a:p>
          <a:p>
            <a:r>
              <a:rPr lang="en-GB"/>
              <a:t>:&lt;48&amp;FPG&lt;7.0 #C70039</a:t>
            </a:r>
          </a:p>
          <a:p>
            <a:r>
              <a:rPr lang="en-GB"/>
              <a:t>:&lt;48,FPG&lt;7.0 #C70039</a:t>
            </a:r>
          </a:p>
          <a:p>
            <a:r>
              <a:rPr lang="en-GB"/>
              <a:t>:&lt;48ORFPG&lt;7.0 #C70039</a:t>
            </a:r>
          </a:p>
          <a:p>
            <a:r>
              <a:rPr lang="en-GB"/>
              <a:t>:&lt;48&amp;FPG&lt;7.0 #C70039</a:t>
            </a:r>
          </a:p>
          <a:p>
            <a:endParaRPr lang="en-GB"/>
          </a:p>
          <a:p>
            <a:r>
              <a:rPr lang="en-GB"/>
              <a:t>Drug element present [1] at18m</a:t>
            </a:r>
          </a:p>
          <a:p>
            <a:r>
              <a:rPr lang="en-GB"/>
              <a:t>at18m [1]&lt;48</a:t>
            </a:r>
          </a:p>
          <a:p>
            <a:endParaRPr lang="en-GB"/>
          </a:p>
          <a:p>
            <a:r>
              <a:rPr lang="en-GB"/>
              <a:t>:at18m #5D6D7E</a:t>
            </a:r>
          </a:p>
          <a:p>
            <a:r>
              <a:rPr lang="en-GB"/>
              <a:t>:&lt;48 #5D6D7E</a:t>
            </a:r>
          </a:p>
          <a:p>
            <a:endParaRPr lang="en-GB"/>
          </a:p>
          <a:p>
            <a:r>
              <a:rPr lang="en-GB"/>
              <a:t>Drug element present [5] at 1y</a:t>
            </a:r>
          </a:p>
          <a:p>
            <a:r>
              <a:rPr lang="en-GB"/>
              <a:t> at 1y [2] &lt;48&amp;FPG&lt;7.0</a:t>
            </a:r>
          </a:p>
          <a:p>
            <a:r>
              <a:rPr lang="en-GB"/>
              <a:t> at 1y [1] &lt;48,FPG&lt;7.0</a:t>
            </a:r>
          </a:p>
          <a:p>
            <a:r>
              <a:rPr lang="en-GB"/>
              <a:t>at 1y [2] &lt;48</a:t>
            </a:r>
          </a:p>
          <a:p>
            <a:endParaRPr lang="en-GB"/>
          </a:p>
          <a:p>
            <a:r>
              <a:rPr lang="en-GB"/>
              <a:t>:at 1y #5D6D7E</a:t>
            </a:r>
          </a:p>
          <a:p>
            <a:endParaRPr lang="en-GB"/>
          </a:p>
          <a:p>
            <a:r>
              <a:rPr lang="en-GB"/>
              <a:t>:&lt;48 #5D6D7E</a:t>
            </a:r>
          </a:p>
          <a:p>
            <a:r>
              <a:rPr lang="en-GB"/>
              <a:t>:&lt;48,FPG&lt;7.0 #5D6D7E</a:t>
            </a:r>
          </a:p>
          <a:p>
            <a:r>
              <a:rPr lang="en-GB"/>
              <a:t>:&lt;48&amp;FPG&lt;7.0 #5D6D7E</a:t>
            </a:r>
          </a:p>
          <a:p>
            <a:endParaRPr lang="en-GB"/>
          </a:p>
          <a:p>
            <a:r>
              <a:rPr lang="en-GB"/>
              <a:t>Drug element present [1] "For 90 days"</a:t>
            </a:r>
          </a:p>
          <a:p>
            <a:r>
              <a:rPr lang="en-GB"/>
              <a:t> "For 90 days" [1]&lt;48ORFPG&lt;7.0</a:t>
            </a:r>
          </a:p>
          <a:p>
            <a:endParaRPr lang="en-GB"/>
          </a:p>
          <a:p>
            <a:r>
              <a:rPr lang="en-GB"/>
              <a:t>:"For 90 days" #5D6D7E</a:t>
            </a:r>
          </a:p>
          <a:p>
            <a:r>
              <a:rPr lang="en-GB"/>
              <a:t>:&lt;48ORFPG&lt;7.0 #5D6D7E</a:t>
            </a:r>
          </a:p>
          <a:p>
            <a:endParaRPr lang="en-GB"/>
          </a:p>
          <a:p>
            <a:endParaRPr lang="en-GB"/>
          </a:p>
          <a:p>
            <a:endParaRPr lang="en-GB"/>
          </a:p>
          <a:p>
            <a:r>
              <a:rPr lang="en-GB"/>
              <a:t>Drug element present [26]for 1y</a:t>
            </a:r>
          </a:p>
          <a:p>
            <a:r>
              <a:rPr lang="en-GB"/>
              <a:t> for 1y[1]&lt;53</a:t>
            </a:r>
          </a:p>
          <a:p>
            <a:r>
              <a:rPr lang="en-GB"/>
              <a:t>for 1y [1]&lt;46</a:t>
            </a:r>
          </a:p>
          <a:p>
            <a:r>
              <a:rPr lang="en-GB"/>
              <a:t>for 1y [1]FPG&lt;7.0</a:t>
            </a:r>
          </a:p>
          <a:p>
            <a:r>
              <a:rPr lang="en-GB"/>
              <a:t>for 1y[9]&lt;48 </a:t>
            </a:r>
          </a:p>
          <a:p>
            <a:r>
              <a:rPr lang="en-GB"/>
              <a:t>for 1y [4]&lt;48,FPG&lt;7.0</a:t>
            </a:r>
          </a:p>
          <a:p>
            <a:r>
              <a:rPr lang="en-GB"/>
              <a:t>for 1y[10]&lt;48&amp;FPG&lt;7.0</a:t>
            </a:r>
          </a:p>
          <a:p>
            <a:r>
              <a:rPr lang="en-GB"/>
              <a:t> </a:t>
            </a:r>
          </a:p>
          <a:p>
            <a:endParaRPr lang="en-GB"/>
          </a:p>
          <a:p>
            <a:r>
              <a:rPr lang="en-GB"/>
              <a:t> :for 1y  #5D6D7E</a:t>
            </a:r>
          </a:p>
          <a:p>
            <a:r>
              <a:rPr lang="en-GB"/>
              <a:t>:&lt;53 #5D6D7E</a:t>
            </a:r>
          </a:p>
          <a:p>
            <a:r>
              <a:rPr lang="en-GB"/>
              <a:t>:&lt;46 #5D6D7E</a:t>
            </a:r>
          </a:p>
          <a:p>
            <a:r>
              <a:rPr lang="en-GB"/>
              <a:t>:FPG&lt;7.0 #5D6D7E</a:t>
            </a:r>
          </a:p>
          <a:p>
            <a:r>
              <a:rPr lang="en-GB"/>
              <a:t>:&lt;48 #5D6D7E</a:t>
            </a:r>
          </a:p>
          <a:p>
            <a:r>
              <a:rPr lang="en-GB"/>
              <a:t>:&lt;48,FPG&lt;7.0 #5D6D7E</a:t>
            </a:r>
          </a:p>
          <a:p>
            <a:r>
              <a:rPr lang="en-GB"/>
              <a:t>:&lt;48&amp;FPG&lt;7.0  #5D6D7E</a:t>
            </a:r>
          </a:p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27F2FC4-DA11-A149-8DA6-A9037C1576BE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840240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B71EB0-A153-7845-918D-63EE233F411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BAA1199-ECCF-794F-B788-7B118390CED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484017F-2D67-7940-87BB-F3E67B84E9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14677F-AA0A-8D4F-8408-BD5CA6904827}" type="datetimeFigureOut">
              <a:rPr lang="en-US" smtClean="0"/>
              <a:t>9/24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47AB245-E958-AF4A-8771-36DE472503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31F8159-0DB0-6F46-A540-364E0ED0DA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20D7D5-A9DC-6644-AD84-0972CB56AB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55416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D8F296C-0359-F940-8858-359C4F93CF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7CA3596-925B-3E41-9006-4F113CCC1DF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BB8D450-72C4-6049-AE21-A5ADE356CA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14677F-AA0A-8D4F-8408-BD5CA6904827}" type="datetimeFigureOut">
              <a:rPr lang="en-US" smtClean="0"/>
              <a:t>9/24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515A521-501C-E446-BC62-6AC0E2CDFE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F8C7F82-B7A0-F34F-9FE3-A1E6332098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20D7D5-A9DC-6644-AD84-0972CB56AB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83089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E172C73-F359-0840-9EC0-404F3B2D2F5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526BBBC-5D13-B04F-8B0C-82AAF321816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C02147A-3DE4-6A47-91CA-1E41350F49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14677F-AA0A-8D4F-8408-BD5CA6904827}" type="datetimeFigureOut">
              <a:rPr lang="en-US" smtClean="0"/>
              <a:t>9/24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70F8119-AE33-A241-9D92-2B3027A28B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1DF7C97-4D99-FB4C-92C6-C0D3C6089F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20D7D5-A9DC-6644-AD84-0972CB56AB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16283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55A5AC-672F-4642-8662-7285C99D2A9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35D8094-4684-2842-A93D-0B212E6D802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D7C8053-5441-754A-9C65-CD2AB775DD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14677F-AA0A-8D4F-8408-BD5CA6904827}" type="datetimeFigureOut">
              <a:rPr lang="en-US" smtClean="0"/>
              <a:t>9/24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22387DD-F2B3-0440-8788-FD56321F9C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B4921E4-3639-4947-96B6-0712984A42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20D7D5-A9DC-6644-AD84-0972CB56AB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42521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728924-E957-994B-8C78-3B0E7048EA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AD109CB-3594-A54E-A34A-76018C888C5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1D7F986-5A61-8B4D-8D4F-069C81260C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14677F-AA0A-8D4F-8408-BD5CA6904827}" type="datetimeFigureOut">
              <a:rPr lang="en-US" smtClean="0"/>
              <a:t>9/24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487894D-9405-E545-B2BF-5ABD179AE8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74871DA-9CE5-BB4F-8325-1678BA1F3A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20D7D5-A9DC-6644-AD84-0972CB56AB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5277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45D345-0204-2F4C-9D88-1C84951427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C9492AF-542A-6A46-9ABC-DB5D53C8739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4E1AC9E-4545-6546-9A8C-7F4CA4EE9F0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4401E09-7817-8741-9E8F-C617AA36C9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14677F-AA0A-8D4F-8408-BD5CA6904827}" type="datetimeFigureOut">
              <a:rPr lang="en-US" smtClean="0"/>
              <a:t>9/24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73BF4BC-5CEF-D64E-9D57-787461016D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7E667AA-8379-4540-91AA-43F6653A44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20D7D5-A9DC-6644-AD84-0972CB56AB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53929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2B8941-1A83-3A4D-B4A7-9EB1F59B1F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1AF4C62-9D87-5F43-B3C4-0A63819A736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B5E6EBA-77EC-4E45-8681-83804B238FA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5A4F034-819B-5349-895D-CC1B85CFF60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5D84BBF-4DB3-0440-858E-D2D952AE9A1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F639079-22A0-EF4B-B999-21354FCE02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14677F-AA0A-8D4F-8408-BD5CA6904827}" type="datetimeFigureOut">
              <a:rPr lang="en-US" smtClean="0"/>
              <a:t>9/24/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2BA785E-FD98-EA47-91EE-EEFD92375F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8A9AE3C-AF1C-8348-BE73-DC3ED0CB99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20D7D5-A9DC-6644-AD84-0972CB56AB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42553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89F673-A059-B34A-BA62-D6083790D39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5BBE93A-29D6-C444-81FF-02F1B985CE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14677F-AA0A-8D4F-8408-BD5CA6904827}" type="datetimeFigureOut">
              <a:rPr lang="en-US" smtClean="0"/>
              <a:t>9/24/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4D3209C-2E6F-DE45-98A1-3DB3CF5CE8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3E90635-2AD0-DD48-9560-F25434C144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20D7D5-A9DC-6644-AD84-0972CB56AB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82394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76EBF65-8D31-4F4E-A328-DFC976FA28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14677F-AA0A-8D4F-8408-BD5CA6904827}" type="datetimeFigureOut">
              <a:rPr lang="en-US" smtClean="0"/>
              <a:t>9/24/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3FECE7E-12B5-8942-AF0B-FB0C254B2B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53E4620-0605-5445-9CE2-036CB067F8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20D7D5-A9DC-6644-AD84-0972CB56AB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03843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525AF9-5494-0144-9036-47D1A30DF5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7A7A4FA-F0C7-5345-BF47-739BFBF7C6C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DA44600-BCB1-724C-BA94-DB8C56B4A45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F51C26D-61D7-9D43-908E-387E9EA00B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14677F-AA0A-8D4F-8408-BD5CA6904827}" type="datetimeFigureOut">
              <a:rPr lang="en-US" smtClean="0"/>
              <a:t>9/24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FACD2E3-BC60-0240-881C-B77655981E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FB4D528-ED3C-E342-9B27-BB96E9BFF4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20D7D5-A9DC-6644-AD84-0972CB56AB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25505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A29AEA-27A5-8245-A8EB-25C9AF0E762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32172F6-7064-5543-8287-D040533EEF7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E0BCB8F-1486-A642-9A64-71C9235907C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892C211-46FF-EF4E-A5DF-361DA4C399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14677F-AA0A-8D4F-8408-BD5CA6904827}" type="datetimeFigureOut">
              <a:rPr lang="en-US" smtClean="0"/>
              <a:t>9/24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5749704-3DF3-5C44-AF93-84F7D607F1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7578A23-EB0C-6348-AF5B-CDEF1BE326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20D7D5-A9DC-6644-AD84-0972CB56AB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89971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7A4CA3D-6954-614C-9CCC-417E897E63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483812A-645A-934C-BFBE-11CCCFF2D70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4EFFEDD-3BC2-2047-B528-4DACBE82558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14677F-AA0A-8D4F-8408-BD5CA6904827}" type="datetimeFigureOut">
              <a:rPr lang="en-US" smtClean="0"/>
              <a:t>9/24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8DBA127-E216-C540-91A3-F10317F346B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9949627-11AC-D044-BD3E-3062F688B2B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20D7D5-A9DC-6644-AD84-0972CB56AB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08036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" name="Picture 18" descr="A close up of a logo&#10;&#10;Description automatically generated">
            <a:extLst>
              <a:ext uri="{FF2B5EF4-FFF2-40B4-BE49-F238E27FC236}">
                <a16:creationId xmlns:a16="http://schemas.microsoft.com/office/drawing/2014/main" id="{5DC9AC65-E788-1B42-9244-29C9F6FBD30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046641" y="399235"/>
            <a:ext cx="6034269" cy="603426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5797883D-3E89-EA48-A325-BAEAE30F482B}"/>
              </a:ext>
            </a:extLst>
          </p:cNvPr>
          <p:cNvSpPr txBox="1"/>
          <p:nvPr/>
        </p:nvSpPr>
        <p:spPr>
          <a:xfrm>
            <a:off x="2127265" y="3018534"/>
            <a:ext cx="110130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>
                <a:latin typeface="Times" pitchFamily="2" charset="0"/>
              </a:rPr>
              <a:t>57 </a:t>
            </a:r>
          </a:p>
          <a:p>
            <a:pPr algn="ctr"/>
            <a:r>
              <a:rPr lang="en-GB" sz="800">
                <a:latin typeface="Times" pitchFamily="2" charset="0"/>
              </a:rPr>
              <a:t>Partial Remission definitions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4EC93D70-416C-3A46-B728-F188B8DBE8C7}"/>
              </a:ext>
            </a:extLst>
          </p:cNvPr>
          <p:cNvSpPr txBox="1"/>
          <p:nvPr/>
        </p:nvSpPr>
        <p:spPr>
          <a:xfrm>
            <a:off x="2677915" y="4948490"/>
            <a:ext cx="23626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800">
                <a:latin typeface="Times" pitchFamily="2" charset="0"/>
              </a:rPr>
              <a:t>missing: 3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A269398-F077-8C43-89F5-419FDFA7C440}"/>
              </a:ext>
            </a:extLst>
          </p:cNvPr>
          <p:cNvSpPr txBox="1"/>
          <p:nvPr/>
        </p:nvSpPr>
        <p:spPr>
          <a:xfrm>
            <a:off x="3854770" y="5402874"/>
            <a:ext cx="11859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800">
                <a:latin typeface="Times" pitchFamily="2" charset="0"/>
              </a:rPr>
              <a:t>“Some” GLT: 5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81AEC1B-41F0-854C-A136-7F80F35D707F}"/>
              </a:ext>
            </a:extLst>
          </p:cNvPr>
          <p:cNvSpPr txBox="1"/>
          <p:nvPr/>
        </p:nvSpPr>
        <p:spPr>
          <a:xfrm>
            <a:off x="5787966" y="2012098"/>
            <a:ext cx="1181540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GB" sz="800">
                <a:latin typeface="Times" pitchFamily="2" charset="0"/>
              </a:rPr>
              <a:t>missing: 20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15CAF97-542B-9049-BE45-E92EF6DA6752}"/>
              </a:ext>
            </a:extLst>
          </p:cNvPr>
          <p:cNvSpPr txBox="1"/>
          <p:nvPr/>
        </p:nvSpPr>
        <p:spPr>
          <a:xfrm>
            <a:off x="4100253" y="3876195"/>
            <a:ext cx="2875241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GB" sz="800">
                <a:latin typeface="Times" pitchFamily="2" charset="0"/>
              </a:rPr>
              <a:t>for 1 year: 26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8AE0A09-71D1-3548-A001-0E5CAE346B0F}"/>
              </a:ext>
            </a:extLst>
          </p:cNvPr>
          <p:cNvSpPr txBox="1"/>
          <p:nvPr/>
        </p:nvSpPr>
        <p:spPr>
          <a:xfrm>
            <a:off x="5852976" y="5340842"/>
            <a:ext cx="1116530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GB" sz="800">
                <a:latin typeface="Times" pitchFamily="2" charset="0"/>
              </a:rPr>
              <a:t>at 1 year: 8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F828307F-5FD3-2E4C-A14A-57076ED87A24}"/>
              </a:ext>
            </a:extLst>
          </p:cNvPr>
          <p:cNvSpPr txBox="1"/>
          <p:nvPr/>
        </p:nvSpPr>
        <p:spPr>
          <a:xfrm>
            <a:off x="5518544" y="5918049"/>
            <a:ext cx="1473048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GB" sz="800">
                <a:latin typeface="Times" pitchFamily="2" charset="0"/>
              </a:rPr>
              <a:t>for 90 days: 1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57A4E5F0-2C86-DD4A-827E-E77DE396B2D9}"/>
              </a:ext>
            </a:extLst>
          </p:cNvPr>
          <p:cNvSpPr txBox="1"/>
          <p:nvPr/>
        </p:nvSpPr>
        <p:spPr>
          <a:xfrm>
            <a:off x="4293700" y="6165727"/>
            <a:ext cx="2699018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GB" sz="800">
                <a:latin typeface="Times" pitchFamily="2" charset="0"/>
              </a:rPr>
              <a:t>for 6 months:1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04DFE9BB-9F96-3043-BB8C-DAD55F4B74A5}"/>
              </a:ext>
            </a:extLst>
          </p:cNvPr>
          <p:cNvSpPr txBox="1"/>
          <p:nvPr/>
        </p:nvSpPr>
        <p:spPr>
          <a:xfrm>
            <a:off x="2955602" y="3285565"/>
            <a:ext cx="208106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800">
                <a:latin typeface="Times" pitchFamily="2" charset="0"/>
              </a:rPr>
              <a:t>absence of GLT specified: 49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C7B363C4-B16D-6146-8C79-94F359F2F597}"/>
              </a:ext>
            </a:extLst>
          </p:cNvPr>
          <p:cNvSpPr txBox="1"/>
          <p:nvPr/>
        </p:nvSpPr>
        <p:spPr>
          <a:xfrm>
            <a:off x="8936070" y="3292140"/>
            <a:ext cx="29088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>
                <a:latin typeface="Times" pitchFamily="2" charset="0"/>
              </a:rPr>
              <a:t>HbA1c &lt;48mmol/mol &amp; FPG &lt;7.0mmol/l: 17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918CFCEE-0431-8641-852A-EAD2962DD760}"/>
              </a:ext>
            </a:extLst>
          </p:cNvPr>
          <p:cNvSpPr txBox="1"/>
          <p:nvPr/>
        </p:nvSpPr>
        <p:spPr>
          <a:xfrm>
            <a:off x="8946718" y="1383691"/>
            <a:ext cx="25149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>
                <a:latin typeface="Times" pitchFamily="2" charset="0"/>
              </a:rPr>
              <a:t>HbA1c &lt;48mmol/mol: 23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5DED7A72-3714-9E4F-881B-A72532520D91}"/>
              </a:ext>
            </a:extLst>
          </p:cNvPr>
          <p:cNvSpPr txBox="1"/>
          <p:nvPr/>
        </p:nvSpPr>
        <p:spPr>
          <a:xfrm>
            <a:off x="8967711" y="2461499"/>
            <a:ext cx="25149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>
                <a:latin typeface="Times" pitchFamily="2" charset="0"/>
              </a:rPr>
              <a:t>normoglycaemia:1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95781C09-D7B9-5948-93EA-CD398D41CF7D}"/>
              </a:ext>
            </a:extLst>
          </p:cNvPr>
          <p:cNvSpPr txBox="1"/>
          <p:nvPr/>
        </p:nvSpPr>
        <p:spPr>
          <a:xfrm>
            <a:off x="8971351" y="424799"/>
            <a:ext cx="25149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>
                <a:latin typeface="Times" pitchFamily="2" charset="0"/>
              </a:rPr>
              <a:t>2009 consensus criteria :1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F461E7F4-6C62-E449-970D-2F6808C40281}"/>
              </a:ext>
            </a:extLst>
          </p:cNvPr>
          <p:cNvSpPr txBox="1"/>
          <p:nvPr/>
        </p:nvSpPr>
        <p:spPr>
          <a:xfrm>
            <a:off x="8953314" y="5141264"/>
            <a:ext cx="25149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>
                <a:latin typeface="Times" pitchFamily="2" charset="0"/>
              </a:rPr>
              <a:t>HbA1c &lt;53mmol/mol :1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402CA355-09C4-8B4E-B6B4-C94B69269ABE}"/>
              </a:ext>
            </a:extLst>
          </p:cNvPr>
          <p:cNvSpPr txBox="1"/>
          <p:nvPr/>
        </p:nvSpPr>
        <p:spPr>
          <a:xfrm>
            <a:off x="8967711" y="5386664"/>
            <a:ext cx="25149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>
                <a:latin typeface="Times" pitchFamily="2" charset="0"/>
              </a:rPr>
              <a:t>HbA1c &lt;46mmol/mol :1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F92AC358-63E2-4F48-AB7C-8392ADE3389A}"/>
              </a:ext>
            </a:extLst>
          </p:cNvPr>
          <p:cNvSpPr txBox="1"/>
          <p:nvPr/>
        </p:nvSpPr>
        <p:spPr>
          <a:xfrm>
            <a:off x="8967711" y="5661323"/>
            <a:ext cx="25149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>
                <a:latin typeface="Times" pitchFamily="2" charset="0"/>
              </a:rPr>
              <a:t>FPG &lt;7.0mmol/l:1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7F0C78BE-D106-E143-AB1C-3258E7320876}"/>
              </a:ext>
            </a:extLst>
          </p:cNvPr>
          <p:cNvSpPr txBox="1"/>
          <p:nvPr/>
        </p:nvSpPr>
        <p:spPr>
          <a:xfrm>
            <a:off x="8946717" y="5900849"/>
            <a:ext cx="25149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>
                <a:latin typeface="Times" pitchFamily="2" charset="0"/>
              </a:rPr>
              <a:t> HbA1c &lt;42mmol/mol :1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DA6FF2C1-7271-574B-85D2-C7F0BBF39936}"/>
              </a:ext>
            </a:extLst>
          </p:cNvPr>
          <p:cNvSpPr txBox="1"/>
          <p:nvPr/>
        </p:nvSpPr>
        <p:spPr>
          <a:xfrm>
            <a:off x="8967710" y="6147678"/>
            <a:ext cx="25149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>
                <a:latin typeface="Times" pitchFamily="2" charset="0"/>
              </a:rPr>
              <a:t>ADA criteria:1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3227689" y="6382659"/>
            <a:ext cx="185001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7200">
              <a:defRPr/>
            </a:pPr>
            <a:r>
              <a:rPr lang="en-GB" sz="800" kern="0">
                <a:solidFill>
                  <a:prstClr val="black"/>
                </a:solidFill>
                <a:latin typeface="Times" pitchFamily="2" charset="0"/>
                <a:cs typeface="Arial" panose="020B0604020202020204" pitchFamily="34" charset="0"/>
              </a:rPr>
              <a:t>GLT component</a:t>
            </a:r>
          </a:p>
          <a:p>
            <a:pPr defTabSz="457200">
              <a:defRPr/>
            </a:pPr>
            <a:r>
              <a:rPr lang="en-GB" sz="800" kern="0">
                <a:solidFill>
                  <a:prstClr val="black"/>
                </a:solidFill>
                <a:latin typeface="Times" pitchFamily="2" charset="0"/>
                <a:cs typeface="Arial" panose="020B0604020202020204" pitchFamily="34" charset="0"/>
              </a:rPr>
              <a:t>Reported 2 ways </a:t>
            </a:r>
          </a:p>
          <a:p>
            <a:pPr defTabSz="457200">
              <a:defRPr/>
            </a:pPr>
            <a:endParaRPr lang="en-GB" sz="800" kern="0">
              <a:solidFill>
                <a:prstClr val="black"/>
              </a:solidFill>
              <a:latin typeface="Times" pitchFamily="2" charset="0"/>
              <a:cs typeface="Arial" panose="020B060402020202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5133052" y="6372112"/>
            <a:ext cx="192982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7200">
              <a:defRPr/>
            </a:pPr>
            <a:r>
              <a:rPr lang="en-GB" sz="800" kern="0">
                <a:solidFill>
                  <a:prstClr val="black"/>
                </a:solidFill>
                <a:latin typeface="Times" pitchFamily="2" charset="0"/>
                <a:cs typeface="Arial" panose="020B0604020202020204" pitchFamily="34" charset="0"/>
              </a:rPr>
              <a:t>Time component</a:t>
            </a:r>
          </a:p>
          <a:p>
            <a:pPr defTabSz="457200">
              <a:defRPr/>
            </a:pPr>
            <a:r>
              <a:rPr lang="en-GB" sz="800" kern="0">
                <a:solidFill>
                  <a:prstClr val="black"/>
                </a:solidFill>
                <a:latin typeface="Times" pitchFamily="2" charset="0"/>
                <a:cs typeface="Arial" panose="020B0604020202020204" pitchFamily="34" charset="0"/>
              </a:rPr>
              <a:t>Reported 5 ways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7000651" y="6375636"/>
            <a:ext cx="231647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7200">
              <a:defRPr/>
            </a:pPr>
            <a:r>
              <a:rPr lang="en-GB" sz="800" kern="0">
                <a:solidFill>
                  <a:prstClr val="black"/>
                </a:solidFill>
                <a:latin typeface="Times" pitchFamily="2" charset="0"/>
                <a:cs typeface="Arial" panose="020B0604020202020204" pitchFamily="34" charset="0"/>
              </a:rPr>
              <a:t>Glycaemic component</a:t>
            </a:r>
          </a:p>
          <a:p>
            <a:pPr defTabSz="457200">
              <a:defRPr/>
            </a:pPr>
            <a:r>
              <a:rPr lang="en-GB" sz="800" kern="0">
                <a:solidFill>
                  <a:prstClr val="black"/>
                </a:solidFill>
                <a:latin typeface="Times" pitchFamily="2" charset="0"/>
                <a:cs typeface="Arial" panose="020B0604020202020204" pitchFamily="34" charset="0"/>
              </a:rPr>
              <a:t>Reported 11 ways</a:t>
            </a:r>
          </a:p>
        </p:txBody>
      </p:sp>
      <p:cxnSp>
        <p:nvCxnSpPr>
          <p:cNvPr id="30" name="Straight Connector 29"/>
          <p:cNvCxnSpPr>
            <a:cxnSpLocks/>
          </p:cNvCxnSpPr>
          <p:nvPr/>
        </p:nvCxnSpPr>
        <p:spPr>
          <a:xfrm>
            <a:off x="6992718" y="6302699"/>
            <a:ext cx="0" cy="801492"/>
          </a:xfrm>
          <a:prstGeom prst="line">
            <a:avLst/>
          </a:prstGeom>
          <a:noFill/>
          <a:ln w="6350" cap="flat" cmpd="sng" algn="ctr">
            <a:solidFill>
              <a:sysClr val="windowText" lastClr="000000"/>
            </a:solidFill>
            <a:prstDash val="lgDash"/>
            <a:miter lim="800000"/>
          </a:ln>
          <a:effectLst/>
        </p:spPr>
      </p:cxnSp>
      <p:cxnSp>
        <p:nvCxnSpPr>
          <p:cNvPr id="31" name="Straight Connector 30"/>
          <p:cNvCxnSpPr/>
          <p:nvPr/>
        </p:nvCxnSpPr>
        <p:spPr>
          <a:xfrm flipH="1">
            <a:off x="5125118" y="5762816"/>
            <a:ext cx="1" cy="1341375"/>
          </a:xfrm>
          <a:prstGeom prst="line">
            <a:avLst/>
          </a:prstGeom>
          <a:noFill/>
          <a:ln w="6350" cap="flat" cmpd="sng" algn="ctr">
            <a:solidFill>
              <a:sysClr val="windowText" lastClr="000000"/>
            </a:solidFill>
            <a:prstDash val="lgDash"/>
            <a:miter lim="800000"/>
          </a:ln>
          <a:effectLst/>
        </p:spPr>
      </p:cxnSp>
      <p:cxnSp>
        <p:nvCxnSpPr>
          <p:cNvPr id="32" name="Straight Connector 31"/>
          <p:cNvCxnSpPr/>
          <p:nvPr/>
        </p:nvCxnSpPr>
        <p:spPr>
          <a:xfrm>
            <a:off x="3219020" y="5329098"/>
            <a:ext cx="6768" cy="1727882"/>
          </a:xfrm>
          <a:prstGeom prst="line">
            <a:avLst/>
          </a:prstGeom>
          <a:noFill/>
          <a:ln w="6350" cap="flat" cmpd="sng" algn="ctr">
            <a:solidFill>
              <a:sysClr val="windowText" lastClr="000000"/>
            </a:solidFill>
            <a:prstDash val="lgDash"/>
            <a:miter lim="800000"/>
          </a:ln>
          <a:effectLst/>
        </p:spPr>
      </p:cxnSp>
      <p:sp>
        <p:nvSpPr>
          <p:cNvPr id="33" name="TextBox 32">
            <a:extLst>
              <a:ext uri="{FF2B5EF4-FFF2-40B4-BE49-F238E27FC236}">
                <a16:creationId xmlns:a16="http://schemas.microsoft.com/office/drawing/2014/main" id="{5D4759CB-8A34-EF46-AD17-9C74253354B3}"/>
              </a:ext>
            </a:extLst>
          </p:cNvPr>
          <p:cNvSpPr txBox="1"/>
          <p:nvPr/>
        </p:nvSpPr>
        <p:spPr>
          <a:xfrm>
            <a:off x="8967711" y="4678303"/>
            <a:ext cx="268140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>
                <a:latin typeface="Times" pitchFamily="2" charset="0"/>
              </a:rPr>
              <a:t>HbA1c &lt;48mmol/mol, FPG &lt;7.0mmol/l: 7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F9F5F2C9-9D15-7C4A-892C-0924D5639381}"/>
              </a:ext>
            </a:extLst>
          </p:cNvPr>
          <p:cNvSpPr txBox="1"/>
          <p:nvPr/>
        </p:nvSpPr>
        <p:spPr>
          <a:xfrm>
            <a:off x="8967711" y="4154316"/>
            <a:ext cx="29088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>
                <a:latin typeface="Times" pitchFamily="2" charset="0"/>
              </a:rPr>
              <a:t>HbA1c &lt;48mmol/mol or FPG &lt;7.0mmol/l: 3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472D4A5B-7368-3A4F-A5EE-984C962B6926}"/>
              </a:ext>
            </a:extLst>
          </p:cNvPr>
          <p:cNvSpPr txBox="1"/>
          <p:nvPr/>
        </p:nvSpPr>
        <p:spPr>
          <a:xfrm>
            <a:off x="5852976" y="1160438"/>
            <a:ext cx="1116530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GB" sz="800">
                <a:latin typeface="Times" pitchFamily="2" charset="0"/>
              </a:rPr>
              <a:t>at 18 months:1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DEBE7E83-37A9-EB4A-B5D8-3A02867923A3}"/>
              </a:ext>
            </a:extLst>
          </p:cNvPr>
          <p:cNvSpPr/>
          <p:nvPr/>
        </p:nvSpPr>
        <p:spPr>
          <a:xfrm>
            <a:off x="0" y="29416"/>
            <a:ext cx="12191993" cy="28027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1000"/>
              </a:spcAft>
            </a:pPr>
            <a:r>
              <a:rPr lang="en-GB" sz="1200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1 Fig: Sankey Diagram to illustrate heterogeneity for each component of the remission definition: glucose lowering therapy, time and glycaemic component for Unspecified Remission</a:t>
            </a:r>
            <a:endParaRPr lang="en-GB" sz="1100" b="1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125054D0-0017-7B4B-8CA0-55E55E3A2B09}"/>
              </a:ext>
            </a:extLst>
          </p:cNvPr>
          <p:cNvSpPr/>
          <p:nvPr/>
        </p:nvSpPr>
        <p:spPr>
          <a:xfrm>
            <a:off x="0" y="534270"/>
            <a:ext cx="4530398" cy="25667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050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Red indicates missing or ambiguous within each component only</a:t>
            </a:r>
            <a:endParaRPr lang="en-GB" sz="1050" b="1" dirty="0"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437960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</TotalTime>
  <Words>714</Words>
  <Application>Microsoft Macintosh PowerPoint</Application>
  <PresentationFormat>Widescreen</PresentationFormat>
  <Paragraphs>130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APTIEUX Rae</dc:creator>
  <cp:lastModifiedBy>CAPTIEUX Rae</cp:lastModifiedBy>
  <cp:revision>3</cp:revision>
  <dcterms:created xsi:type="dcterms:W3CDTF">2020-09-01T19:34:41Z</dcterms:created>
  <dcterms:modified xsi:type="dcterms:W3CDTF">2020-09-24T21:31:54Z</dcterms:modified>
</cp:coreProperties>
</file>